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3"/>
  </p:notesMasterIdLst>
  <p:sldIdLst>
    <p:sldId id="257" r:id="rId2"/>
  </p:sldIdLst>
  <p:sldSz cx="8640763" cy="68405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B1B94"/>
    <a:srgbClr val="800000"/>
    <a:srgbClr val="FF0000"/>
    <a:srgbClr val="008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201A65C-00FF-4FC4-9952-2198F55CC064}" v="19" dt="2025-03-05T03:40:08.58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302" autoAdjust="0"/>
    <p:restoredTop sz="94660"/>
  </p:normalViewPr>
  <p:slideViewPr>
    <p:cSldViewPr snapToGrid="0">
      <p:cViewPr varScale="1">
        <p:scale>
          <a:sx n="151" d="100"/>
          <a:sy n="151" d="100"/>
        </p:scale>
        <p:origin x="2424" y="84"/>
      </p:cViewPr>
      <p:guideLst/>
    </p:cSldViewPr>
  </p:slideViewPr>
  <p:notesTextViewPr>
    <p:cViewPr>
      <p:scale>
        <a:sx n="75" d="100"/>
        <a:sy n="75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airam Vutla" userId="1cccb2eb-ae5a-48c8-8f83-807e20de976e" providerId="ADAL" clId="{E201A65C-00FF-4FC4-9952-2198F55CC064}"/>
    <pc:docChg chg="undo redo custSel addSld delSld modSld modMainMaster">
      <pc:chgData name="Sairam Vutla" userId="1cccb2eb-ae5a-48c8-8f83-807e20de976e" providerId="ADAL" clId="{E201A65C-00FF-4FC4-9952-2198F55CC064}" dt="2025-03-05T03:40:08.584" v="648" actId="338"/>
      <pc:docMkLst>
        <pc:docMk/>
      </pc:docMkLst>
      <pc:sldChg chg="delSp modSp del mod">
        <pc:chgData name="Sairam Vutla" userId="1cccb2eb-ae5a-48c8-8f83-807e20de976e" providerId="ADAL" clId="{E201A65C-00FF-4FC4-9952-2198F55CC064}" dt="2025-03-04T15:03:18.119" v="631" actId="2696"/>
        <pc:sldMkLst>
          <pc:docMk/>
          <pc:sldMk cId="3688972086" sldId="256"/>
        </pc:sldMkLst>
        <pc:spChg chg="mod">
          <ac:chgData name="Sairam Vutla" userId="1cccb2eb-ae5a-48c8-8f83-807e20de976e" providerId="ADAL" clId="{E201A65C-00FF-4FC4-9952-2198F55CC064}" dt="2025-03-04T14:40:10" v="350" actId="1038"/>
          <ac:spMkLst>
            <pc:docMk/>
            <pc:sldMk cId="3688972086" sldId="256"/>
            <ac:spMk id="7" creationId="{0A67C342-8A31-C22A-BE50-CFF260B9A909}"/>
          </ac:spMkLst>
        </pc:spChg>
        <pc:spChg chg="mod">
          <ac:chgData name="Sairam Vutla" userId="1cccb2eb-ae5a-48c8-8f83-807e20de976e" providerId="ADAL" clId="{E201A65C-00FF-4FC4-9952-2198F55CC064}" dt="2025-03-04T13:56:56.101" v="2"/>
          <ac:spMkLst>
            <pc:docMk/>
            <pc:sldMk cId="3688972086" sldId="256"/>
            <ac:spMk id="8" creationId="{74D2D657-6C4E-26F9-14C4-A951D7C0DBD4}"/>
          </ac:spMkLst>
        </pc:spChg>
        <pc:spChg chg="mod">
          <ac:chgData name="Sairam Vutla" userId="1cccb2eb-ae5a-48c8-8f83-807e20de976e" providerId="ADAL" clId="{E201A65C-00FF-4FC4-9952-2198F55CC064}" dt="2025-03-04T13:56:56.101" v="2"/>
          <ac:spMkLst>
            <pc:docMk/>
            <pc:sldMk cId="3688972086" sldId="256"/>
            <ac:spMk id="9" creationId="{67147B8E-2013-3399-CAD6-56CC46F2F963}"/>
          </ac:spMkLst>
        </pc:spChg>
        <pc:spChg chg="mod">
          <ac:chgData name="Sairam Vutla" userId="1cccb2eb-ae5a-48c8-8f83-807e20de976e" providerId="ADAL" clId="{E201A65C-00FF-4FC4-9952-2198F55CC064}" dt="2025-03-04T13:56:56.101" v="2"/>
          <ac:spMkLst>
            <pc:docMk/>
            <pc:sldMk cId="3688972086" sldId="256"/>
            <ac:spMk id="10" creationId="{7059DAC0-2E7A-B2E8-C999-30C56D1E6447}"/>
          </ac:spMkLst>
        </pc:spChg>
        <pc:spChg chg="mod">
          <ac:chgData name="Sairam Vutla" userId="1cccb2eb-ae5a-48c8-8f83-807e20de976e" providerId="ADAL" clId="{E201A65C-00FF-4FC4-9952-2198F55CC064}" dt="2025-03-04T13:56:56.101" v="2"/>
          <ac:spMkLst>
            <pc:docMk/>
            <pc:sldMk cId="3688972086" sldId="256"/>
            <ac:spMk id="11" creationId="{53AF95C9-F3BA-7A2F-3F54-81C228844B16}"/>
          </ac:spMkLst>
        </pc:spChg>
        <pc:spChg chg="mod">
          <ac:chgData name="Sairam Vutla" userId="1cccb2eb-ae5a-48c8-8f83-807e20de976e" providerId="ADAL" clId="{E201A65C-00FF-4FC4-9952-2198F55CC064}" dt="2025-03-04T13:56:56.101" v="2"/>
          <ac:spMkLst>
            <pc:docMk/>
            <pc:sldMk cId="3688972086" sldId="256"/>
            <ac:spMk id="12" creationId="{048B9DC3-50A0-C850-A50E-C95897CE70D3}"/>
          </ac:spMkLst>
        </pc:spChg>
        <pc:spChg chg="mod">
          <ac:chgData name="Sairam Vutla" userId="1cccb2eb-ae5a-48c8-8f83-807e20de976e" providerId="ADAL" clId="{E201A65C-00FF-4FC4-9952-2198F55CC064}" dt="2025-03-04T13:56:56.101" v="2"/>
          <ac:spMkLst>
            <pc:docMk/>
            <pc:sldMk cId="3688972086" sldId="256"/>
            <ac:spMk id="13" creationId="{4AFD2655-64FE-E998-8342-6065EE652307}"/>
          </ac:spMkLst>
        </pc:spChg>
        <pc:grpChg chg="del mod">
          <ac:chgData name="Sairam Vutla" userId="1cccb2eb-ae5a-48c8-8f83-807e20de976e" providerId="ADAL" clId="{E201A65C-00FF-4FC4-9952-2198F55CC064}" dt="2025-03-04T15:03:13.308" v="630" actId="21"/>
          <ac:grpSpMkLst>
            <pc:docMk/>
            <pc:sldMk cId="3688972086" sldId="256"/>
            <ac:grpSpMk id="6" creationId="{77B439A4-80E7-3D9F-AD27-757A8C6CE00E}"/>
          </ac:grpSpMkLst>
        </pc:grpChg>
        <pc:picChg chg="del mod">
          <ac:chgData name="Sairam Vutla" userId="1cccb2eb-ae5a-48c8-8f83-807e20de976e" providerId="ADAL" clId="{E201A65C-00FF-4FC4-9952-2198F55CC064}" dt="2025-03-04T15:03:13.308" v="630" actId="21"/>
          <ac:picMkLst>
            <pc:docMk/>
            <pc:sldMk cId="3688972086" sldId="256"/>
            <ac:picMk id="5" creationId="{61C78622-F942-5A73-4A8C-893486E724F8}"/>
          </ac:picMkLst>
        </pc:picChg>
      </pc:sldChg>
      <pc:sldChg chg="addSp delSp modSp mod">
        <pc:chgData name="Sairam Vutla" userId="1cccb2eb-ae5a-48c8-8f83-807e20de976e" providerId="ADAL" clId="{E201A65C-00FF-4FC4-9952-2198F55CC064}" dt="2025-03-05T03:40:08.584" v="648" actId="338"/>
        <pc:sldMkLst>
          <pc:docMk/>
          <pc:sldMk cId="3547290739" sldId="257"/>
        </pc:sldMkLst>
        <pc:spChg chg="add mod topLvl">
          <ac:chgData name="Sairam Vutla" userId="1cccb2eb-ae5a-48c8-8f83-807e20de976e" providerId="ADAL" clId="{E201A65C-00FF-4FC4-9952-2198F55CC064}" dt="2025-03-05T03:40:08.584" v="648" actId="338"/>
          <ac:spMkLst>
            <pc:docMk/>
            <pc:sldMk cId="3547290739" sldId="257"/>
            <ac:spMk id="2" creationId="{D4346A8B-9D69-7D60-568C-5E17B2F2D8CA}"/>
          </ac:spMkLst>
        </pc:spChg>
        <pc:spChg chg="mod">
          <ac:chgData name="Sairam Vutla" userId="1cccb2eb-ae5a-48c8-8f83-807e20de976e" providerId="ADAL" clId="{E201A65C-00FF-4FC4-9952-2198F55CC064}" dt="2025-03-05T03:39:23.579" v="640" actId="165"/>
          <ac:spMkLst>
            <pc:docMk/>
            <pc:sldMk cId="3547290739" sldId="257"/>
            <ac:spMk id="7" creationId="{B1DD2B7D-33F0-0306-E2CC-4D9C2F42C6CD}"/>
          </ac:spMkLst>
        </pc:spChg>
        <pc:spChg chg="mod">
          <ac:chgData name="Sairam Vutla" userId="1cccb2eb-ae5a-48c8-8f83-807e20de976e" providerId="ADAL" clId="{E201A65C-00FF-4FC4-9952-2198F55CC064}" dt="2025-03-05T03:39:23.579" v="640" actId="165"/>
          <ac:spMkLst>
            <pc:docMk/>
            <pc:sldMk cId="3547290739" sldId="257"/>
            <ac:spMk id="8" creationId="{8B659121-7416-3AA5-4D56-27289852B578}"/>
          </ac:spMkLst>
        </pc:spChg>
        <pc:spChg chg="mod">
          <ac:chgData name="Sairam Vutla" userId="1cccb2eb-ae5a-48c8-8f83-807e20de976e" providerId="ADAL" clId="{E201A65C-00FF-4FC4-9952-2198F55CC064}" dt="2025-03-04T15:59:30.204" v="633" actId="165"/>
          <ac:spMkLst>
            <pc:docMk/>
            <pc:sldMk cId="3547290739" sldId="257"/>
            <ac:spMk id="9" creationId="{CFDB8398-7C46-5CD3-1781-E2E49F2043CA}"/>
          </ac:spMkLst>
        </pc:spChg>
        <pc:spChg chg="mod">
          <ac:chgData name="Sairam Vutla" userId="1cccb2eb-ae5a-48c8-8f83-807e20de976e" providerId="ADAL" clId="{E201A65C-00FF-4FC4-9952-2198F55CC064}" dt="2025-03-05T03:39:23.579" v="640" actId="165"/>
          <ac:spMkLst>
            <pc:docMk/>
            <pc:sldMk cId="3547290739" sldId="257"/>
            <ac:spMk id="10" creationId="{44FF8E1B-4410-231D-3AA4-832DCE6D62C7}"/>
          </ac:spMkLst>
        </pc:spChg>
        <pc:spChg chg="mod">
          <ac:chgData name="Sairam Vutla" userId="1cccb2eb-ae5a-48c8-8f83-807e20de976e" providerId="ADAL" clId="{E201A65C-00FF-4FC4-9952-2198F55CC064}" dt="2025-03-05T03:39:23.579" v="640" actId="165"/>
          <ac:spMkLst>
            <pc:docMk/>
            <pc:sldMk cId="3547290739" sldId="257"/>
            <ac:spMk id="11" creationId="{1B4B7065-CD91-6B04-9980-D538FB47C4E1}"/>
          </ac:spMkLst>
        </pc:spChg>
        <pc:spChg chg="mod">
          <ac:chgData name="Sairam Vutla" userId="1cccb2eb-ae5a-48c8-8f83-807e20de976e" providerId="ADAL" clId="{E201A65C-00FF-4FC4-9952-2198F55CC064}" dt="2025-03-04T15:59:30.204" v="633" actId="165"/>
          <ac:spMkLst>
            <pc:docMk/>
            <pc:sldMk cId="3547290739" sldId="257"/>
            <ac:spMk id="12" creationId="{2F31A54C-4EFF-5233-E0A6-15F11B2D016E}"/>
          </ac:spMkLst>
        </pc:spChg>
        <pc:spChg chg="mod">
          <ac:chgData name="Sairam Vutla" userId="1cccb2eb-ae5a-48c8-8f83-807e20de976e" providerId="ADAL" clId="{E201A65C-00FF-4FC4-9952-2198F55CC064}" dt="2025-03-05T03:39:23.579" v="640" actId="165"/>
          <ac:spMkLst>
            <pc:docMk/>
            <pc:sldMk cId="3547290739" sldId="257"/>
            <ac:spMk id="13" creationId="{02868FA2-7C12-A0FF-3CBB-FA659CDD89B9}"/>
          </ac:spMkLst>
        </pc:spChg>
        <pc:spChg chg="mod topLvl">
          <ac:chgData name="Sairam Vutla" userId="1cccb2eb-ae5a-48c8-8f83-807e20de976e" providerId="ADAL" clId="{E201A65C-00FF-4FC4-9952-2198F55CC064}" dt="2025-03-04T15:59:30.204" v="633" actId="165"/>
          <ac:spMkLst>
            <pc:docMk/>
            <pc:sldMk cId="3547290739" sldId="257"/>
            <ac:spMk id="14" creationId="{B0D99888-D8CB-ABE4-2F7E-108AE92A70EB}"/>
          </ac:spMkLst>
        </pc:spChg>
        <pc:spChg chg="mod">
          <ac:chgData name="Sairam Vutla" userId="1cccb2eb-ae5a-48c8-8f83-807e20de976e" providerId="ADAL" clId="{E201A65C-00FF-4FC4-9952-2198F55CC064}" dt="2025-03-04T15:59:30.204" v="633" actId="165"/>
          <ac:spMkLst>
            <pc:docMk/>
            <pc:sldMk cId="3547290739" sldId="257"/>
            <ac:spMk id="15" creationId="{0DC8972A-3EE5-06C2-31C4-97D39D0BDBF7}"/>
          </ac:spMkLst>
        </pc:spChg>
        <pc:spChg chg="mod topLvl">
          <ac:chgData name="Sairam Vutla" userId="1cccb2eb-ae5a-48c8-8f83-807e20de976e" providerId="ADAL" clId="{E201A65C-00FF-4FC4-9952-2198F55CC064}" dt="2025-03-04T14:49:06.685" v="531" actId="164"/>
          <ac:spMkLst>
            <pc:docMk/>
            <pc:sldMk cId="3547290739" sldId="257"/>
            <ac:spMk id="16" creationId="{0B9C1CC9-178F-85BA-A9AF-1B7694A7AD3D}"/>
          </ac:spMkLst>
        </pc:spChg>
        <pc:spChg chg="mod">
          <ac:chgData name="Sairam Vutla" userId="1cccb2eb-ae5a-48c8-8f83-807e20de976e" providerId="ADAL" clId="{E201A65C-00FF-4FC4-9952-2198F55CC064}" dt="2025-03-05T03:39:23.579" v="640" actId="165"/>
          <ac:spMkLst>
            <pc:docMk/>
            <pc:sldMk cId="3547290739" sldId="257"/>
            <ac:spMk id="17" creationId="{EF933098-2C36-782D-CB6E-512FE00E7E24}"/>
          </ac:spMkLst>
        </pc:spChg>
        <pc:spChg chg="mod">
          <ac:chgData name="Sairam Vutla" userId="1cccb2eb-ae5a-48c8-8f83-807e20de976e" providerId="ADAL" clId="{E201A65C-00FF-4FC4-9952-2198F55CC064}" dt="2025-03-04T15:59:30.204" v="633" actId="165"/>
          <ac:spMkLst>
            <pc:docMk/>
            <pc:sldMk cId="3547290739" sldId="257"/>
            <ac:spMk id="20" creationId="{A8FE4FE2-4C4E-573D-86DA-F28E5B261091}"/>
          </ac:spMkLst>
        </pc:spChg>
        <pc:spChg chg="mod">
          <ac:chgData name="Sairam Vutla" userId="1cccb2eb-ae5a-48c8-8f83-807e20de976e" providerId="ADAL" clId="{E201A65C-00FF-4FC4-9952-2198F55CC064}" dt="2025-03-05T03:39:23.579" v="640" actId="165"/>
          <ac:spMkLst>
            <pc:docMk/>
            <pc:sldMk cId="3547290739" sldId="257"/>
            <ac:spMk id="21" creationId="{AFEC3616-D6CA-1FA4-40F0-6CD7EEECD644}"/>
          </ac:spMkLst>
        </pc:spChg>
        <pc:spChg chg="mod">
          <ac:chgData name="Sairam Vutla" userId="1cccb2eb-ae5a-48c8-8f83-807e20de976e" providerId="ADAL" clId="{E201A65C-00FF-4FC4-9952-2198F55CC064}" dt="2025-03-05T03:39:23.579" v="640" actId="165"/>
          <ac:spMkLst>
            <pc:docMk/>
            <pc:sldMk cId="3547290739" sldId="257"/>
            <ac:spMk id="22" creationId="{2E41ABFE-B191-3B8B-FC9E-A69885084CC9}"/>
          </ac:spMkLst>
        </pc:spChg>
        <pc:spChg chg="mod topLvl">
          <ac:chgData name="Sairam Vutla" userId="1cccb2eb-ae5a-48c8-8f83-807e20de976e" providerId="ADAL" clId="{E201A65C-00FF-4FC4-9952-2198F55CC064}" dt="2025-03-05T03:39:23.579" v="640" actId="165"/>
          <ac:spMkLst>
            <pc:docMk/>
            <pc:sldMk cId="3547290739" sldId="257"/>
            <ac:spMk id="23" creationId="{11B9AFF1-4A43-B016-8A18-306E6616AF12}"/>
          </ac:spMkLst>
        </pc:spChg>
        <pc:spChg chg="mod topLvl">
          <ac:chgData name="Sairam Vutla" userId="1cccb2eb-ae5a-48c8-8f83-807e20de976e" providerId="ADAL" clId="{E201A65C-00FF-4FC4-9952-2198F55CC064}" dt="2025-03-05T03:40:08.584" v="648" actId="338"/>
          <ac:spMkLst>
            <pc:docMk/>
            <pc:sldMk cId="3547290739" sldId="257"/>
            <ac:spMk id="26" creationId="{FC2E985D-E2F8-7A3D-70A5-5757BAB040FA}"/>
          </ac:spMkLst>
        </pc:spChg>
        <pc:grpChg chg="add mod">
          <ac:chgData name="Sairam Vutla" userId="1cccb2eb-ae5a-48c8-8f83-807e20de976e" providerId="ADAL" clId="{E201A65C-00FF-4FC4-9952-2198F55CC064}" dt="2025-03-05T03:40:08.584" v="648" actId="338"/>
          <ac:grpSpMkLst>
            <pc:docMk/>
            <pc:sldMk cId="3547290739" sldId="257"/>
            <ac:grpSpMk id="3" creationId="{6422973E-0CA3-B681-4790-52EC42C7DF31}"/>
          </ac:grpSpMkLst>
        </pc:grpChg>
        <pc:grpChg chg="add mod">
          <ac:chgData name="Sairam Vutla" userId="1cccb2eb-ae5a-48c8-8f83-807e20de976e" providerId="ADAL" clId="{E201A65C-00FF-4FC4-9952-2198F55CC064}" dt="2025-03-04T16:00:02.667" v="634" actId="338"/>
          <ac:grpSpMkLst>
            <pc:docMk/>
            <pc:sldMk cId="3547290739" sldId="257"/>
            <ac:grpSpMk id="4" creationId="{7967C26E-BDCE-CA04-C0B6-804423BF1BC2}"/>
          </ac:grpSpMkLst>
        </pc:grpChg>
        <pc:grpChg chg="add mod">
          <ac:chgData name="Sairam Vutla" userId="1cccb2eb-ae5a-48c8-8f83-807e20de976e" providerId="ADAL" clId="{E201A65C-00FF-4FC4-9952-2198F55CC064}" dt="2025-03-04T14:51:22.022" v="590" actId="164"/>
          <ac:grpSpMkLst>
            <pc:docMk/>
            <pc:sldMk cId="3547290739" sldId="257"/>
            <ac:grpSpMk id="4" creationId="{F09C8E6F-6B77-0146-51F3-2E055F0FAFAB}"/>
          </ac:grpSpMkLst>
        </pc:grpChg>
        <pc:grpChg chg="mod">
          <ac:chgData name="Sairam Vutla" userId="1cccb2eb-ae5a-48c8-8f83-807e20de976e" providerId="ADAL" clId="{E201A65C-00FF-4FC4-9952-2198F55CC064}" dt="2025-03-05T03:40:08.584" v="648" actId="338"/>
          <ac:grpSpMkLst>
            <pc:docMk/>
            <pc:sldMk cId="3547290739" sldId="257"/>
            <ac:grpSpMk id="6" creationId="{69E96377-06E2-B53E-D836-FE6799F04139}"/>
          </ac:grpSpMkLst>
        </pc:grpChg>
        <pc:grpChg chg="add mod">
          <ac:chgData name="Sairam Vutla" userId="1cccb2eb-ae5a-48c8-8f83-807e20de976e" providerId="ADAL" clId="{E201A65C-00FF-4FC4-9952-2198F55CC064}" dt="2025-03-05T03:30:45.478" v="638" actId="338"/>
          <ac:grpSpMkLst>
            <pc:docMk/>
            <pc:sldMk cId="3547290739" sldId="257"/>
            <ac:grpSpMk id="18" creationId="{9A5D3387-8DDA-BCF4-5136-E5E84A958717}"/>
          </ac:grpSpMkLst>
        </pc:grpChg>
        <pc:grpChg chg="add mod">
          <ac:chgData name="Sairam Vutla" userId="1cccb2eb-ae5a-48c8-8f83-807e20de976e" providerId="ADAL" clId="{E201A65C-00FF-4FC4-9952-2198F55CC064}" dt="2025-03-04T15:02:26.238" v="629" actId="164"/>
          <ac:grpSpMkLst>
            <pc:docMk/>
            <pc:sldMk cId="3547290739" sldId="257"/>
            <ac:grpSpMk id="18" creationId="{D0922B7A-6A03-98DE-5DD4-73DB10F56C81}"/>
          </ac:grpSpMkLst>
        </pc:grpChg>
        <pc:grpChg chg="add mod">
          <ac:chgData name="Sairam Vutla" userId="1cccb2eb-ae5a-48c8-8f83-807e20de976e" providerId="ADAL" clId="{E201A65C-00FF-4FC4-9952-2198F55CC064}" dt="2025-03-05T03:40:08.584" v="648" actId="338"/>
          <ac:grpSpMkLst>
            <pc:docMk/>
            <pc:sldMk cId="3547290739" sldId="257"/>
            <ac:grpSpMk id="19" creationId="{64B78489-0E5C-9ABA-0415-52EAAC79C5A5}"/>
          </ac:grpSpMkLst>
        </pc:grpChg>
        <pc:grpChg chg="mod">
          <ac:chgData name="Sairam Vutla" userId="1cccb2eb-ae5a-48c8-8f83-807e20de976e" providerId="ADAL" clId="{E201A65C-00FF-4FC4-9952-2198F55CC064}" dt="2025-03-04T14:00:58.797" v="54" actId="1037"/>
          <ac:grpSpMkLst>
            <pc:docMk/>
            <pc:sldMk cId="3547290739" sldId="257"/>
            <ac:grpSpMk id="27" creationId="{24CCC1A9-7A30-D318-B5EF-66F449857415}"/>
          </ac:grpSpMkLst>
        </pc:grpChg>
        <pc:picChg chg="mod">
          <ac:chgData name="Sairam Vutla" userId="1cccb2eb-ae5a-48c8-8f83-807e20de976e" providerId="ADAL" clId="{E201A65C-00FF-4FC4-9952-2198F55CC064}" dt="2025-03-05T03:40:08.584" v="648" actId="338"/>
          <ac:picMkLst>
            <pc:docMk/>
            <pc:sldMk cId="3547290739" sldId="257"/>
            <ac:picMk id="5" creationId="{3DE86D50-D5A5-3B3D-FC1E-D850C8808BEE}"/>
          </ac:picMkLst>
        </pc:picChg>
      </pc:sldChg>
      <pc:sldChg chg="addSp delSp new add del mod">
        <pc:chgData name="Sairam Vutla" userId="1cccb2eb-ae5a-48c8-8f83-807e20de976e" providerId="ADAL" clId="{E201A65C-00FF-4FC4-9952-2198F55CC064}" dt="2025-03-04T15:03:21.724" v="632" actId="2696"/>
        <pc:sldMkLst>
          <pc:docMk/>
          <pc:sldMk cId="1390331162" sldId="258"/>
        </pc:sldMkLst>
        <pc:spChg chg="add del">
          <ac:chgData name="Sairam Vutla" userId="1cccb2eb-ae5a-48c8-8f83-807e20de976e" providerId="ADAL" clId="{E201A65C-00FF-4FC4-9952-2198F55CC064}" dt="2025-03-04T13:57:32.086" v="13" actId="478"/>
          <ac:spMkLst>
            <pc:docMk/>
            <pc:sldMk cId="1390331162" sldId="258"/>
            <ac:spMk id="2" creationId="{D7544A76-6489-4E86-23ED-992A94D4C9AF}"/>
          </ac:spMkLst>
        </pc:spChg>
        <pc:spChg chg="add del">
          <ac:chgData name="Sairam Vutla" userId="1cccb2eb-ae5a-48c8-8f83-807e20de976e" providerId="ADAL" clId="{E201A65C-00FF-4FC4-9952-2198F55CC064}" dt="2025-03-04T13:57:32.086" v="13" actId="478"/>
          <ac:spMkLst>
            <pc:docMk/>
            <pc:sldMk cId="1390331162" sldId="258"/>
            <ac:spMk id="3" creationId="{D71C728C-CFEE-7F5E-5921-5AFBAF7610A2}"/>
          </ac:spMkLst>
        </pc:spChg>
      </pc:sldChg>
      <pc:sldMasterChg chg="modSp modSldLayout">
        <pc:chgData name="Sairam Vutla" userId="1cccb2eb-ae5a-48c8-8f83-807e20de976e" providerId="ADAL" clId="{E201A65C-00FF-4FC4-9952-2198F55CC064}" dt="2025-03-04T13:56:56.101" v="2"/>
        <pc:sldMasterMkLst>
          <pc:docMk/>
          <pc:sldMasterMk cId="142604304" sldId="2147483672"/>
        </pc:sldMasterMkLst>
        <pc:spChg chg="mod">
          <ac:chgData name="Sairam Vutla" userId="1cccb2eb-ae5a-48c8-8f83-807e20de976e" providerId="ADAL" clId="{E201A65C-00FF-4FC4-9952-2198F55CC064}" dt="2025-03-04T13:56:56.101" v="2"/>
          <ac:spMkLst>
            <pc:docMk/>
            <pc:sldMasterMk cId="142604304" sldId="2147483672"/>
            <ac:spMk id="2" creationId="{00000000-0000-0000-0000-000000000000}"/>
          </ac:spMkLst>
        </pc:spChg>
        <pc:spChg chg="mod">
          <ac:chgData name="Sairam Vutla" userId="1cccb2eb-ae5a-48c8-8f83-807e20de976e" providerId="ADAL" clId="{E201A65C-00FF-4FC4-9952-2198F55CC064}" dt="2025-03-04T13:56:56.101" v="2"/>
          <ac:spMkLst>
            <pc:docMk/>
            <pc:sldMasterMk cId="142604304" sldId="2147483672"/>
            <ac:spMk id="3" creationId="{00000000-0000-0000-0000-000000000000}"/>
          </ac:spMkLst>
        </pc:spChg>
        <pc:spChg chg="mod">
          <ac:chgData name="Sairam Vutla" userId="1cccb2eb-ae5a-48c8-8f83-807e20de976e" providerId="ADAL" clId="{E201A65C-00FF-4FC4-9952-2198F55CC064}" dt="2025-03-04T13:56:56.101" v="2"/>
          <ac:spMkLst>
            <pc:docMk/>
            <pc:sldMasterMk cId="142604304" sldId="2147483672"/>
            <ac:spMk id="4" creationId="{00000000-0000-0000-0000-000000000000}"/>
          </ac:spMkLst>
        </pc:spChg>
        <pc:spChg chg="mod">
          <ac:chgData name="Sairam Vutla" userId="1cccb2eb-ae5a-48c8-8f83-807e20de976e" providerId="ADAL" clId="{E201A65C-00FF-4FC4-9952-2198F55CC064}" dt="2025-03-04T13:56:56.101" v="2"/>
          <ac:spMkLst>
            <pc:docMk/>
            <pc:sldMasterMk cId="142604304" sldId="2147483672"/>
            <ac:spMk id="5" creationId="{00000000-0000-0000-0000-000000000000}"/>
          </ac:spMkLst>
        </pc:spChg>
        <pc:spChg chg="mod">
          <ac:chgData name="Sairam Vutla" userId="1cccb2eb-ae5a-48c8-8f83-807e20de976e" providerId="ADAL" clId="{E201A65C-00FF-4FC4-9952-2198F55CC064}" dt="2025-03-04T13:56:56.101" v="2"/>
          <ac:spMkLst>
            <pc:docMk/>
            <pc:sldMasterMk cId="142604304" sldId="2147483672"/>
            <ac:spMk id="6" creationId="{00000000-0000-0000-0000-000000000000}"/>
          </ac:spMkLst>
        </pc:spChg>
        <pc:sldLayoutChg chg="modSp">
          <pc:chgData name="Sairam Vutla" userId="1cccb2eb-ae5a-48c8-8f83-807e20de976e" providerId="ADAL" clId="{E201A65C-00FF-4FC4-9952-2198F55CC064}" dt="2025-03-04T13:56:56.101" v="2"/>
          <pc:sldLayoutMkLst>
            <pc:docMk/>
            <pc:sldMasterMk cId="142604304" sldId="2147483672"/>
            <pc:sldLayoutMk cId="1801164951" sldId="2147483673"/>
          </pc:sldLayoutMkLst>
          <pc:spChg chg="mod">
            <ac:chgData name="Sairam Vutla" userId="1cccb2eb-ae5a-48c8-8f83-807e20de976e" providerId="ADAL" clId="{E201A65C-00FF-4FC4-9952-2198F55CC064}" dt="2025-03-04T13:56:56.101" v="2"/>
            <ac:spMkLst>
              <pc:docMk/>
              <pc:sldMasterMk cId="142604304" sldId="2147483672"/>
              <pc:sldLayoutMk cId="1801164951" sldId="2147483673"/>
              <ac:spMk id="2" creationId="{00000000-0000-0000-0000-000000000000}"/>
            </ac:spMkLst>
          </pc:spChg>
          <pc:spChg chg="mod">
            <ac:chgData name="Sairam Vutla" userId="1cccb2eb-ae5a-48c8-8f83-807e20de976e" providerId="ADAL" clId="{E201A65C-00FF-4FC4-9952-2198F55CC064}" dt="2025-03-04T13:56:56.101" v="2"/>
            <ac:spMkLst>
              <pc:docMk/>
              <pc:sldMasterMk cId="142604304" sldId="2147483672"/>
              <pc:sldLayoutMk cId="1801164951" sldId="2147483673"/>
              <ac:spMk id="3" creationId="{00000000-0000-0000-0000-000000000000}"/>
            </ac:spMkLst>
          </pc:spChg>
        </pc:sldLayoutChg>
        <pc:sldLayoutChg chg="modSp">
          <pc:chgData name="Sairam Vutla" userId="1cccb2eb-ae5a-48c8-8f83-807e20de976e" providerId="ADAL" clId="{E201A65C-00FF-4FC4-9952-2198F55CC064}" dt="2025-03-04T13:56:56.101" v="2"/>
          <pc:sldLayoutMkLst>
            <pc:docMk/>
            <pc:sldMasterMk cId="142604304" sldId="2147483672"/>
            <pc:sldLayoutMk cId="3013951286" sldId="2147483675"/>
          </pc:sldLayoutMkLst>
          <pc:spChg chg="mod">
            <ac:chgData name="Sairam Vutla" userId="1cccb2eb-ae5a-48c8-8f83-807e20de976e" providerId="ADAL" clId="{E201A65C-00FF-4FC4-9952-2198F55CC064}" dt="2025-03-04T13:56:56.101" v="2"/>
            <ac:spMkLst>
              <pc:docMk/>
              <pc:sldMasterMk cId="142604304" sldId="2147483672"/>
              <pc:sldLayoutMk cId="3013951286" sldId="2147483675"/>
              <ac:spMk id="2" creationId="{00000000-0000-0000-0000-000000000000}"/>
            </ac:spMkLst>
          </pc:spChg>
          <pc:spChg chg="mod">
            <ac:chgData name="Sairam Vutla" userId="1cccb2eb-ae5a-48c8-8f83-807e20de976e" providerId="ADAL" clId="{E201A65C-00FF-4FC4-9952-2198F55CC064}" dt="2025-03-04T13:56:56.101" v="2"/>
            <ac:spMkLst>
              <pc:docMk/>
              <pc:sldMasterMk cId="142604304" sldId="2147483672"/>
              <pc:sldLayoutMk cId="3013951286" sldId="2147483675"/>
              <ac:spMk id="3" creationId="{00000000-0000-0000-0000-000000000000}"/>
            </ac:spMkLst>
          </pc:spChg>
        </pc:sldLayoutChg>
        <pc:sldLayoutChg chg="modSp">
          <pc:chgData name="Sairam Vutla" userId="1cccb2eb-ae5a-48c8-8f83-807e20de976e" providerId="ADAL" clId="{E201A65C-00FF-4FC4-9952-2198F55CC064}" dt="2025-03-04T13:56:56.101" v="2"/>
          <pc:sldLayoutMkLst>
            <pc:docMk/>
            <pc:sldMasterMk cId="142604304" sldId="2147483672"/>
            <pc:sldLayoutMk cId="2101585905" sldId="2147483676"/>
          </pc:sldLayoutMkLst>
          <pc:spChg chg="mod">
            <ac:chgData name="Sairam Vutla" userId="1cccb2eb-ae5a-48c8-8f83-807e20de976e" providerId="ADAL" clId="{E201A65C-00FF-4FC4-9952-2198F55CC064}" dt="2025-03-04T13:56:56.101" v="2"/>
            <ac:spMkLst>
              <pc:docMk/>
              <pc:sldMasterMk cId="142604304" sldId="2147483672"/>
              <pc:sldLayoutMk cId="2101585905" sldId="2147483676"/>
              <ac:spMk id="3" creationId="{00000000-0000-0000-0000-000000000000}"/>
            </ac:spMkLst>
          </pc:spChg>
          <pc:spChg chg="mod">
            <ac:chgData name="Sairam Vutla" userId="1cccb2eb-ae5a-48c8-8f83-807e20de976e" providerId="ADAL" clId="{E201A65C-00FF-4FC4-9952-2198F55CC064}" dt="2025-03-04T13:56:56.101" v="2"/>
            <ac:spMkLst>
              <pc:docMk/>
              <pc:sldMasterMk cId="142604304" sldId="2147483672"/>
              <pc:sldLayoutMk cId="2101585905" sldId="2147483676"/>
              <ac:spMk id="4" creationId="{00000000-0000-0000-0000-000000000000}"/>
            </ac:spMkLst>
          </pc:spChg>
        </pc:sldLayoutChg>
        <pc:sldLayoutChg chg="modSp">
          <pc:chgData name="Sairam Vutla" userId="1cccb2eb-ae5a-48c8-8f83-807e20de976e" providerId="ADAL" clId="{E201A65C-00FF-4FC4-9952-2198F55CC064}" dt="2025-03-04T13:56:56.101" v="2"/>
          <pc:sldLayoutMkLst>
            <pc:docMk/>
            <pc:sldMasterMk cId="142604304" sldId="2147483672"/>
            <pc:sldLayoutMk cId="4216928893" sldId="2147483677"/>
          </pc:sldLayoutMkLst>
          <pc:spChg chg="mod">
            <ac:chgData name="Sairam Vutla" userId="1cccb2eb-ae5a-48c8-8f83-807e20de976e" providerId="ADAL" clId="{E201A65C-00FF-4FC4-9952-2198F55CC064}" dt="2025-03-04T13:56:56.101" v="2"/>
            <ac:spMkLst>
              <pc:docMk/>
              <pc:sldMasterMk cId="142604304" sldId="2147483672"/>
              <pc:sldLayoutMk cId="4216928893" sldId="2147483677"/>
              <ac:spMk id="2" creationId="{00000000-0000-0000-0000-000000000000}"/>
            </ac:spMkLst>
          </pc:spChg>
          <pc:spChg chg="mod">
            <ac:chgData name="Sairam Vutla" userId="1cccb2eb-ae5a-48c8-8f83-807e20de976e" providerId="ADAL" clId="{E201A65C-00FF-4FC4-9952-2198F55CC064}" dt="2025-03-04T13:56:56.101" v="2"/>
            <ac:spMkLst>
              <pc:docMk/>
              <pc:sldMasterMk cId="142604304" sldId="2147483672"/>
              <pc:sldLayoutMk cId="4216928893" sldId="2147483677"/>
              <ac:spMk id="3" creationId="{00000000-0000-0000-0000-000000000000}"/>
            </ac:spMkLst>
          </pc:spChg>
          <pc:spChg chg="mod">
            <ac:chgData name="Sairam Vutla" userId="1cccb2eb-ae5a-48c8-8f83-807e20de976e" providerId="ADAL" clId="{E201A65C-00FF-4FC4-9952-2198F55CC064}" dt="2025-03-04T13:56:56.101" v="2"/>
            <ac:spMkLst>
              <pc:docMk/>
              <pc:sldMasterMk cId="142604304" sldId="2147483672"/>
              <pc:sldLayoutMk cId="4216928893" sldId="2147483677"/>
              <ac:spMk id="4" creationId="{00000000-0000-0000-0000-000000000000}"/>
            </ac:spMkLst>
          </pc:spChg>
          <pc:spChg chg="mod">
            <ac:chgData name="Sairam Vutla" userId="1cccb2eb-ae5a-48c8-8f83-807e20de976e" providerId="ADAL" clId="{E201A65C-00FF-4FC4-9952-2198F55CC064}" dt="2025-03-04T13:56:56.101" v="2"/>
            <ac:spMkLst>
              <pc:docMk/>
              <pc:sldMasterMk cId="142604304" sldId="2147483672"/>
              <pc:sldLayoutMk cId="4216928893" sldId="2147483677"/>
              <ac:spMk id="5" creationId="{00000000-0000-0000-0000-000000000000}"/>
            </ac:spMkLst>
          </pc:spChg>
          <pc:spChg chg="mod">
            <ac:chgData name="Sairam Vutla" userId="1cccb2eb-ae5a-48c8-8f83-807e20de976e" providerId="ADAL" clId="{E201A65C-00FF-4FC4-9952-2198F55CC064}" dt="2025-03-04T13:56:56.101" v="2"/>
            <ac:spMkLst>
              <pc:docMk/>
              <pc:sldMasterMk cId="142604304" sldId="2147483672"/>
              <pc:sldLayoutMk cId="4216928893" sldId="2147483677"/>
              <ac:spMk id="6" creationId="{00000000-0000-0000-0000-000000000000}"/>
            </ac:spMkLst>
          </pc:spChg>
        </pc:sldLayoutChg>
        <pc:sldLayoutChg chg="modSp">
          <pc:chgData name="Sairam Vutla" userId="1cccb2eb-ae5a-48c8-8f83-807e20de976e" providerId="ADAL" clId="{E201A65C-00FF-4FC4-9952-2198F55CC064}" dt="2025-03-04T13:56:56.101" v="2"/>
          <pc:sldLayoutMkLst>
            <pc:docMk/>
            <pc:sldMasterMk cId="142604304" sldId="2147483672"/>
            <pc:sldLayoutMk cId="500137097" sldId="2147483680"/>
          </pc:sldLayoutMkLst>
          <pc:spChg chg="mod">
            <ac:chgData name="Sairam Vutla" userId="1cccb2eb-ae5a-48c8-8f83-807e20de976e" providerId="ADAL" clId="{E201A65C-00FF-4FC4-9952-2198F55CC064}" dt="2025-03-04T13:56:56.101" v="2"/>
            <ac:spMkLst>
              <pc:docMk/>
              <pc:sldMasterMk cId="142604304" sldId="2147483672"/>
              <pc:sldLayoutMk cId="500137097" sldId="2147483680"/>
              <ac:spMk id="2" creationId="{00000000-0000-0000-0000-000000000000}"/>
            </ac:spMkLst>
          </pc:spChg>
          <pc:spChg chg="mod">
            <ac:chgData name="Sairam Vutla" userId="1cccb2eb-ae5a-48c8-8f83-807e20de976e" providerId="ADAL" clId="{E201A65C-00FF-4FC4-9952-2198F55CC064}" dt="2025-03-04T13:56:56.101" v="2"/>
            <ac:spMkLst>
              <pc:docMk/>
              <pc:sldMasterMk cId="142604304" sldId="2147483672"/>
              <pc:sldLayoutMk cId="500137097" sldId="2147483680"/>
              <ac:spMk id="3" creationId="{00000000-0000-0000-0000-000000000000}"/>
            </ac:spMkLst>
          </pc:spChg>
          <pc:spChg chg="mod">
            <ac:chgData name="Sairam Vutla" userId="1cccb2eb-ae5a-48c8-8f83-807e20de976e" providerId="ADAL" clId="{E201A65C-00FF-4FC4-9952-2198F55CC064}" dt="2025-03-04T13:56:56.101" v="2"/>
            <ac:spMkLst>
              <pc:docMk/>
              <pc:sldMasterMk cId="142604304" sldId="2147483672"/>
              <pc:sldLayoutMk cId="500137097" sldId="2147483680"/>
              <ac:spMk id="4" creationId="{00000000-0000-0000-0000-000000000000}"/>
            </ac:spMkLst>
          </pc:spChg>
        </pc:sldLayoutChg>
        <pc:sldLayoutChg chg="modSp">
          <pc:chgData name="Sairam Vutla" userId="1cccb2eb-ae5a-48c8-8f83-807e20de976e" providerId="ADAL" clId="{E201A65C-00FF-4FC4-9952-2198F55CC064}" dt="2025-03-04T13:56:56.101" v="2"/>
          <pc:sldLayoutMkLst>
            <pc:docMk/>
            <pc:sldMasterMk cId="142604304" sldId="2147483672"/>
            <pc:sldLayoutMk cId="2856074535" sldId="2147483681"/>
          </pc:sldLayoutMkLst>
          <pc:spChg chg="mod">
            <ac:chgData name="Sairam Vutla" userId="1cccb2eb-ae5a-48c8-8f83-807e20de976e" providerId="ADAL" clId="{E201A65C-00FF-4FC4-9952-2198F55CC064}" dt="2025-03-04T13:56:56.101" v="2"/>
            <ac:spMkLst>
              <pc:docMk/>
              <pc:sldMasterMk cId="142604304" sldId="2147483672"/>
              <pc:sldLayoutMk cId="2856074535" sldId="2147483681"/>
              <ac:spMk id="2" creationId="{00000000-0000-0000-0000-000000000000}"/>
            </ac:spMkLst>
          </pc:spChg>
          <pc:spChg chg="mod">
            <ac:chgData name="Sairam Vutla" userId="1cccb2eb-ae5a-48c8-8f83-807e20de976e" providerId="ADAL" clId="{E201A65C-00FF-4FC4-9952-2198F55CC064}" dt="2025-03-04T13:56:56.101" v="2"/>
            <ac:spMkLst>
              <pc:docMk/>
              <pc:sldMasterMk cId="142604304" sldId="2147483672"/>
              <pc:sldLayoutMk cId="2856074535" sldId="2147483681"/>
              <ac:spMk id="3" creationId="{00000000-0000-0000-0000-000000000000}"/>
            </ac:spMkLst>
          </pc:spChg>
          <pc:spChg chg="mod">
            <ac:chgData name="Sairam Vutla" userId="1cccb2eb-ae5a-48c8-8f83-807e20de976e" providerId="ADAL" clId="{E201A65C-00FF-4FC4-9952-2198F55CC064}" dt="2025-03-04T13:56:56.101" v="2"/>
            <ac:spMkLst>
              <pc:docMk/>
              <pc:sldMasterMk cId="142604304" sldId="2147483672"/>
              <pc:sldLayoutMk cId="2856074535" sldId="2147483681"/>
              <ac:spMk id="4" creationId="{00000000-0000-0000-0000-000000000000}"/>
            </ac:spMkLst>
          </pc:spChg>
        </pc:sldLayoutChg>
        <pc:sldLayoutChg chg="modSp">
          <pc:chgData name="Sairam Vutla" userId="1cccb2eb-ae5a-48c8-8f83-807e20de976e" providerId="ADAL" clId="{E201A65C-00FF-4FC4-9952-2198F55CC064}" dt="2025-03-04T13:56:56.101" v="2"/>
          <pc:sldLayoutMkLst>
            <pc:docMk/>
            <pc:sldMasterMk cId="142604304" sldId="2147483672"/>
            <pc:sldLayoutMk cId="2081808451" sldId="2147483683"/>
          </pc:sldLayoutMkLst>
          <pc:spChg chg="mod">
            <ac:chgData name="Sairam Vutla" userId="1cccb2eb-ae5a-48c8-8f83-807e20de976e" providerId="ADAL" clId="{E201A65C-00FF-4FC4-9952-2198F55CC064}" dt="2025-03-04T13:56:56.101" v="2"/>
            <ac:spMkLst>
              <pc:docMk/>
              <pc:sldMasterMk cId="142604304" sldId="2147483672"/>
              <pc:sldLayoutMk cId="2081808451" sldId="2147483683"/>
              <ac:spMk id="2" creationId="{00000000-0000-0000-0000-000000000000}"/>
            </ac:spMkLst>
          </pc:spChg>
          <pc:spChg chg="mod">
            <ac:chgData name="Sairam Vutla" userId="1cccb2eb-ae5a-48c8-8f83-807e20de976e" providerId="ADAL" clId="{E201A65C-00FF-4FC4-9952-2198F55CC064}" dt="2025-03-04T13:56:56.101" v="2"/>
            <ac:spMkLst>
              <pc:docMk/>
              <pc:sldMasterMk cId="142604304" sldId="2147483672"/>
              <pc:sldLayoutMk cId="2081808451" sldId="2147483683"/>
              <ac:spMk id="3" creationId="{00000000-0000-0000-0000-000000000000}"/>
            </ac:spMkLst>
          </pc:spChg>
        </pc:sldLayoutChg>
      </pc:sldMaster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FCCAA75-3787-4143-AD4D-9724FE124CDB}" type="datetimeFigureOut">
              <a:rPr lang="en-IN" smtClean="0"/>
              <a:t>04-03-2025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479550" y="1143000"/>
            <a:ext cx="38989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2691246-DE0C-4A4B-893D-15850A9C0E9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937287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479550" y="1143000"/>
            <a:ext cx="38989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2691246-DE0C-4A4B-893D-15850A9C0E9C}" type="slidenum">
              <a:rPr lang="en-IN" smtClean="0"/>
              <a:t>1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9121233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48057" y="1119505"/>
            <a:ext cx="7344649" cy="2381521"/>
          </a:xfrm>
        </p:spPr>
        <p:txBody>
          <a:bodyPr anchor="b"/>
          <a:lstStyle>
            <a:lvl1pPr algn="ctr">
              <a:defRPr sz="567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80096" y="3592866"/>
            <a:ext cx="6480572" cy="1651546"/>
          </a:xfrm>
        </p:spPr>
        <p:txBody>
          <a:bodyPr/>
          <a:lstStyle>
            <a:lvl1pPr marL="0" indent="0" algn="ctr">
              <a:buNone/>
              <a:defRPr sz="2268"/>
            </a:lvl1pPr>
            <a:lvl2pPr marL="432054" indent="0" algn="ctr">
              <a:buNone/>
              <a:defRPr sz="1890"/>
            </a:lvl2pPr>
            <a:lvl3pPr marL="864108" indent="0" algn="ctr">
              <a:buNone/>
              <a:defRPr sz="1701"/>
            </a:lvl3pPr>
            <a:lvl4pPr marL="1296162" indent="0" algn="ctr">
              <a:buNone/>
              <a:defRPr sz="1512"/>
            </a:lvl4pPr>
            <a:lvl5pPr marL="1728216" indent="0" algn="ctr">
              <a:buNone/>
              <a:defRPr sz="1512"/>
            </a:lvl5pPr>
            <a:lvl6pPr marL="2160270" indent="0" algn="ctr">
              <a:buNone/>
              <a:defRPr sz="1512"/>
            </a:lvl6pPr>
            <a:lvl7pPr marL="2592324" indent="0" algn="ctr">
              <a:buNone/>
              <a:defRPr sz="1512"/>
            </a:lvl7pPr>
            <a:lvl8pPr marL="3024378" indent="0" algn="ctr">
              <a:buNone/>
              <a:defRPr sz="1512"/>
            </a:lvl8pPr>
            <a:lvl9pPr marL="3456432" indent="0" algn="ctr">
              <a:buNone/>
              <a:defRPr sz="1512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676F7B-0E29-44BA-9962-E90C4412A1C9}" type="datetimeFigureOut">
              <a:rPr lang="en-IN" smtClean="0"/>
              <a:t>04-03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FB439-A0BA-4A5D-ACA1-78B39F66925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427091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676F7B-0E29-44BA-9962-E90C4412A1C9}" type="datetimeFigureOut">
              <a:rPr lang="en-IN" smtClean="0"/>
              <a:t>04-03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FB439-A0BA-4A5D-ACA1-78B39F66925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256651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183546" y="364195"/>
            <a:ext cx="1863165" cy="579704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94053" y="364195"/>
            <a:ext cx="5481484" cy="579704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676F7B-0E29-44BA-9962-E90C4412A1C9}" type="datetimeFigureOut">
              <a:rPr lang="en-IN" smtClean="0"/>
              <a:t>04-03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FB439-A0BA-4A5D-ACA1-78B39F66925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415865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676F7B-0E29-44BA-9962-E90C4412A1C9}" type="datetimeFigureOut">
              <a:rPr lang="en-IN" smtClean="0"/>
              <a:t>04-03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FB439-A0BA-4A5D-ACA1-78B39F66925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112913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89553" y="1705386"/>
            <a:ext cx="7452658" cy="2845473"/>
          </a:xfrm>
        </p:spPr>
        <p:txBody>
          <a:bodyPr anchor="b"/>
          <a:lstStyle>
            <a:lvl1pPr>
              <a:defRPr sz="567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89553" y="4577779"/>
            <a:ext cx="7452658" cy="1496367"/>
          </a:xfrm>
        </p:spPr>
        <p:txBody>
          <a:bodyPr/>
          <a:lstStyle>
            <a:lvl1pPr marL="0" indent="0">
              <a:buNone/>
              <a:defRPr sz="2268">
                <a:solidFill>
                  <a:schemeClr val="tx1">
                    <a:tint val="82000"/>
                  </a:schemeClr>
                </a:solidFill>
              </a:defRPr>
            </a:lvl1pPr>
            <a:lvl2pPr marL="432054" indent="0">
              <a:buNone/>
              <a:defRPr sz="1890">
                <a:solidFill>
                  <a:schemeClr val="tx1">
                    <a:tint val="82000"/>
                  </a:schemeClr>
                </a:solidFill>
              </a:defRPr>
            </a:lvl2pPr>
            <a:lvl3pPr marL="864108" indent="0">
              <a:buNone/>
              <a:defRPr sz="1701">
                <a:solidFill>
                  <a:schemeClr val="tx1">
                    <a:tint val="82000"/>
                  </a:schemeClr>
                </a:solidFill>
              </a:defRPr>
            </a:lvl3pPr>
            <a:lvl4pPr marL="1296162" indent="0">
              <a:buNone/>
              <a:defRPr sz="1512">
                <a:solidFill>
                  <a:schemeClr val="tx1">
                    <a:tint val="82000"/>
                  </a:schemeClr>
                </a:solidFill>
              </a:defRPr>
            </a:lvl4pPr>
            <a:lvl5pPr marL="1728216" indent="0">
              <a:buNone/>
              <a:defRPr sz="1512">
                <a:solidFill>
                  <a:schemeClr val="tx1">
                    <a:tint val="82000"/>
                  </a:schemeClr>
                </a:solidFill>
              </a:defRPr>
            </a:lvl5pPr>
            <a:lvl6pPr marL="2160270" indent="0">
              <a:buNone/>
              <a:defRPr sz="1512">
                <a:solidFill>
                  <a:schemeClr val="tx1">
                    <a:tint val="82000"/>
                  </a:schemeClr>
                </a:solidFill>
              </a:defRPr>
            </a:lvl6pPr>
            <a:lvl7pPr marL="2592324" indent="0">
              <a:buNone/>
              <a:defRPr sz="1512">
                <a:solidFill>
                  <a:schemeClr val="tx1">
                    <a:tint val="82000"/>
                  </a:schemeClr>
                </a:solidFill>
              </a:defRPr>
            </a:lvl7pPr>
            <a:lvl8pPr marL="3024378" indent="0">
              <a:buNone/>
              <a:defRPr sz="1512">
                <a:solidFill>
                  <a:schemeClr val="tx1">
                    <a:tint val="82000"/>
                  </a:schemeClr>
                </a:solidFill>
              </a:defRPr>
            </a:lvl8pPr>
            <a:lvl9pPr marL="3456432" indent="0">
              <a:buNone/>
              <a:defRPr sz="1512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676F7B-0E29-44BA-9962-E90C4412A1C9}" type="datetimeFigureOut">
              <a:rPr lang="en-IN" smtClean="0"/>
              <a:t>04-03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FB439-A0BA-4A5D-ACA1-78B39F66925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175210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94053" y="1820976"/>
            <a:ext cx="3672324" cy="434025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74386" y="1820976"/>
            <a:ext cx="3672324" cy="434025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676F7B-0E29-44BA-9962-E90C4412A1C9}" type="datetimeFigureOut">
              <a:rPr lang="en-IN" smtClean="0"/>
              <a:t>04-03-202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FB439-A0BA-4A5D-ACA1-78B39F66925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922854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5178" y="364197"/>
            <a:ext cx="7452658" cy="132218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5179" y="1676882"/>
            <a:ext cx="3655447" cy="821814"/>
          </a:xfrm>
        </p:spPr>
        <p:txBody>
          <a:bodyPr anchor="b"/>
          <a:lstStyle>
            <a:lvl1pPr marL="0" indent="0">
              <a:buNone/>
              <a:defRPr sz="2268" b="1"/>
            </a:lvl1pPr>
            <a:lvl2pPr marL="432054" indent="0">
              <a:buNone/>
              <a:defRPr sz="1890" b="1"/>
            </a:lvl2pPr>
            <a:lvl3pPr marL="864108" indent="0">
              <a:buNone/>
              <a:defRPr sz="1701" b="1"/>
            </a:lvl3pPr>
            <a:lvl4pPr marL="1296162" indent="0">
              <a:buNone/>
              <a:defRPr sz="1512" b="1"/>
            </a:lvl4pPr>
            <a:lvl5pPr marL="1728216" indent="0">
              <a:buNone/>
              <a:defRPr sz="1512" b="1"/>
            </a:lvl5pPr>
            <a:lvl6pPr marL="2160270" indent="0">
              <a:buNone/>
              <a:defRPr sz="1512" b="1"/>
            </a:lvl6pPr>
            <a:lvl7pPr marL="2592324" indent="0">
              <a:buNone/>
              <a:defRPr sz="1512" b="1"/>
            </a:lvl7pPr>
            <a:lvl8pPr marL="3024378" indent="0">
              <a:buNone/>
              <a:defRPr sz="1512" b="1"/>
            </a:lvl8pPr>
            <a:lvl9pPr marL="3456432" indent="0">
              <a:buNone/>
              <a:defRPr sz="1512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95179" y="2498697"/>
            <a:ext cx="3655447" cy="36752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374387" y="1676882"/>
            <a:ext cx="3673450" cy="821814"/>
          </a:xfrm>
        </p:spPr>
        <p:txBody>
          <a:bodyPr anchor="b"/>
          <a:lstStyle>
            <a:lvl1pPr marL="0" indent="0">
              <a:buNone/>
              <a:defRPr sz="2268" b="1"/>
            </a:lvl1pPr>
            <a:lvl2pPr marL="432054" indent="0">
              <a:buNone/>
              <a:defRPr sz="1890" b="1"/>
            </a:lvl2pPr>
            <a:lvl3pPr marL="864108" indent="0">
              <a:buNone/>
              <a:defRPr sz="1701" b="1"/>
            </a:lvl3pPr>
            <a:lvl4pPr marL="1296162" indent="0">
              <a:buNone/>
              <a:defRPr sz="1512" b="1"/>
            </a:lvl4pPr>
            <a:lvl5pPr marL="1728216" indent="0">
              <a:buNone/>
              <a:defRPr sz="1512" b="1"/>
            </a:lvl5pPr>
            <a:lvl6pPr marL="2160270" indent="0">
              <a:buNone/>
              <a:defRPr sz="1512" b="1"/>
            </a:lvl6pPr>
            <a:lvl7pPr marL="2592324" indent="0">
              <a:buNone/>
              <a:defRPr sz="1512" b="1"/>
            </a:lvl7pPr>
            <a:lvl8pPr marL="3024378" indent="0">
              <a:buNone/>
              <a:defRPr sz="1512" b="1"/>
            </a:lvl8pPr>
            <a:lvl9pPr marL="3456432" indent="0">
              <a:buNone/>
              <a:defRPr sz="1512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374387" y="2498697"/>
            <a:ext cx="3673450" cy="36752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676F7B-0E29-44BA-9962-E90C4412A1C9}" type="datetimeFigureOut">
              <a:rPr lang="en-IN" smtClean="0"/>
              <a:t>04-03-2025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FB439-A0BA-4A5D-ACA1-78B39F66925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735429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676F7B-0E29-44BA-9962-E90C4412A1C9}" type="datetimeFigureOut">
              <a:rPr lang="en-IN" smtClean="0"/>
              <a:t>04-03-2025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FB439-A0BA-4A5D-ACA1-78B39F66925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56132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676F7B-0E29-44BA-9962-E90C4412A1C9}" type="datetimeFigureOut">
              <a:rPr lang="en-IN" smtClean="0"/>
              <a:t>04-03-2025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FB439-A0BA-4A5D-ACA1-78B39F66925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838818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5178" y="456036"/>
            <a:ext cx="2786871" cy="1596126"/>
          </a:xfrm>
        </p:spPr>
        <p:txBody>
          <a:bodyPr anchor="b"/>
          <a:lstStyle>
            <a:lvl1pPr>
              <a:defRPr sz="302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673450" y="984912"/>
            <a:ext cx="4374386" cy="4861216"/>
          </a:xfrm>
        </p:spPr>
        <p:txBody>
          <a:bodyPr/>
          <a:lstStyle>
            <a:lvl1pPr>
              <a:defRPr sz="3024"/>
            </a:lvl1pPr>
            <a:lvl2pPr>
              <a:defRPr sz="2646"/>
            </a:lvl2pPr>
            <a:lvl3pPr>
              <a:defRPr sz="2268"/>
            </a:lvl3pPr>
            <a:lvl4pPr>
              <a:defRPr sz="1890"/>
            </a:lvl4pPr>
            <a:lvl5pPr>
              <a:defRPr sz="1890"/>
            </a:lvl5pPr>
            <a:lvl6pPr>
              <a:defRPr sz="1890"/>
            </a:lvl6pPr>
            <a:lvl7pPr>
              <a:defRPr sz="1890"/>
            </a:lvl7pPr>
            <a:lvl8pPr>
              <a:defRPr sz="1890"/>
            </a:lvl8pPr>
            <a:lvl9pPr>
              <a:defRPr sz="189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95178" y="2052161"/>
            <a:ext cx="2786871" cy="3801883"/>
          </a:xfrm>
        </p:spPr>
        <p:txBody>
          <a:bodyPr/>
          <a:lstStyle>
            <a:lvl1pPr marL="0" indent="0">
              <a:buNone/>
              <a:defRPr sz="1512"/>
            </a:lvl1pPr>
            <a:lvl2pPr marL="432054" indent="0">
              <a:buNone/>
              <a:defRPr sz="1323"/>
            </a:lvl2pPr>
            <a:lvl3pPr marL="864108" indent="0">
              <a:buNone/>
              <a:defRPr sz="1134"/>
            </a:lvl3pPr>
            <a:lvl4pPr marL="1296162" indent="0">
              <a:buNone/>
              <a:defRPr sz="945"/>
            </a:lvl4pPr>
            <a:lvl5pPr marL="1728216" indent="0">
              <a:buNone/>
              <a:defRPr sz="945"/>
            </a:lvl5pPr>
            <a:lvl6pPr marL="2160270" indent="0">
              <a:buNone/>
              <a:defRPr sz="945"/>
            </a:lvl6pPr>
            <a:lvl7pPr marL="2592324" indent="0">
              <a:buNone/>
              <a:defRPr sz="945"/>
            </a:lvl7pPr>
            <a:lvl8pPr marL="3024378" indent="0">
              <a:buNone/>
              <a:defRPr sz="945"/>
            </a:lvl8pPr>
            <a:lvl9pPr marL="3456432" indent="0">
              <a:buNone/>
              <a:defRPr sz="94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676F7B-0E29-44BA-9962-E90C4412A1C9}" type="datetimeFigureOut">
              <a:rPr lang="en-IN" smtClean="0"/>
              <a:t>04-03-202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FB439-A0BA-4A5D-ACA1-78B39F66925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472866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5178" y="456036"/>
            <a:ext cx="2786871" cy="1596126"/>
          </a:xfrm>
        </p:spPr>
        <p:txBody>
          <a:bodyPr anchor="b"/>
          <a:lstStyle>
            <a:lvl1pPr>
              <a:defRPr sz="302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673450" y="984912"/>
            <a:ext cx="4374386" cy="4861216"/>
          </a:xfrm>
        </p:spPr>
        <p:txBody>
          <a:bodyPr anchor="t"/>
          <a:lstStyle>
            <a:lvl1pPr marL="0" indent="0">
              <a:buNone/>
              <a:defRPr sz="3024"/>
            </a:lvl1pPr>
            <a:lvl2pPr marL="432054" indent="0">
              <a:buNone/>
              <a:defRPr sz="2646"/>
            </a:lvl2pPr>
            <a:lvl3pPr marL="864108" indent="0">
              <a:buNone/>
              <a:defRPr sz="2268"/>
            </a:lvl3pPr>
            <a:lvl4pPr marL="1296162" indent="0">
              <a:buNone/>
              <a:defRPr sz="1890"/>
            </a:lvl4pPr>
            <a:lvl5pPr marL="1728216" indent="0">
              <a:buNone/>
              <a:defRPr sz="1890"/>
            </a:lvl5pPr>
            <a:lvl6pPr marL="2160270" indent="0">
              <a:buNone/>
              <a:defRPr sz="1890"/>
            </a:lvl6pPr>
            <a:lvl7pPr marL="2592324" indent="0">
              <a:buNone/>
              <a:defRPr sz="1890"/>
            </a:lvl7pPr>
            <a:lvl8pPr marL="3024378" indent="0">
              <a:buNone/>
              <a:defRPr sz="1890"/>
            </a:lvl8pPr>
            <a:lvl9pPr marL="3456432" indent="0">
              <a:buNone/>
              <a:defRPr sz="189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95178" y="2052161"/>
            <a:ext cx="2786871" cy="3801883"/>
          </a:xfrm>
        </p:spPr>
        <p:txBody>
          <a:bodyPr/>
          <a:lstStyle>
            <a:lvl1pPr marL="0" indent="0">
              <a:buNone/>
              <a:defRPr sz="1512"/>
            </a:lvl1pPr>
            <a:lvl2pPr marL="432054" indent="0">
              <a:buNone/>
              <a:defRPr sz="1323"/>
            </a:lvl2pPr>
            <a:lvl3pPr marL="864108" indent="0">
              <a:buNone/>
              <a:defRPr sz="1134"/>
            </a:lvl3pPr>
            <a:lvl4pPr marL="1296162" indent="0">
              <a:buNone/>
              <a:defRPr sz="945"/>
            </a:lvl4pPr>
            <a:lvl5pPr marL="1728216" indent="0">
              <a:buNone/>
              <a:defRPr sz="945"/>
            </a:lvl5pPr>
            <a:lvl6pPr marL="2160270" indent="0">
              <a:buNone/>
              <a:defRPr sz="945"/>
            </a:lvl6pPr>
            <a:lvl7pPr marL="2592324" indent="0">
              <a:buNone/>
              <a:defRPr sz="945"/>
            </a:lvl7pPr>
            <a:lvl8pPr marL="3024378" indent="0">
              <a:buNone/>
              <a:defRPr sz="945"/>
            </a:lvl8pPr>
            <a:lvl9pPr marL="3456432" indent="0">
              <a:buNone/>
              <a:defRPr sz="94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676F7B-0E29-44BA-9962-E90C4412A1C9}" type="datetimeFigureOut">
              <a:rPr lang="en-IN" smtClean="0"/>
              <a:t>04-03-202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FB439-A0BA-4A5D-ACA1-78B39F66925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340102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94053" y="364197"/>
            <a:ext cx="7452658" cy="13221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4053" y="1820976"/>
            <a:ext cx="7452658" cy="434025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94052" y="6340167"/>
            <a:ext cx="1944172" cy="36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34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E676F7B-0E29-44BA-9962-E90C4412A1C9}" type="datetimeFigureOut">
              <a:rPr lang="en-IN" smtClean="0"/>
              <a:t>04-03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862253" y="6340167"/>
            <a:ext cx="2916258" cy="36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34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102539" y="6340167"/>
            <a:ext cx="1944172" cy="36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34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D1FB439-A0BA-4A5D-ACA1-78B39F66925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167429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864108" rtl="0" eaLnBrk="1" latinLnBrk="0" hangingPunct="1">
        <a:lnSpc>
          <a:spcPct val="90000"/>
        </a:lnSpc>
        <a:spcBef>
          <a:spcPct val="0"/>
        </a:spcBef>
        <a:buNone/>
        <a:defRPr sz="415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16027" indent="-216027" algn="l" defTabSz="864108" rtl="0" eaLnBrk="1" latinLnBrk="0" hangingPunct="1">
        <a:lnSpc>
          <a:spcPct val="90000"/>
        </a:lnSpc>
        <a:spcBef>
          <a:spcPts val="945"/>
        </a:spcBef>
        <a:buFont typeface="Arial" panose="020B0604020202020204" pitchFamily="34" charset="0"/>
        <a:buChar char="•"/>
        <a:defRPr sz="2646" kern="1200">
          <a:solidFill>
            <a:schemeClr val="tx1"/>
          </a:solidFill>
          <a:latin typeface="+mn-lt"/>
          <a:ea typeface="+mn-ea"/>
          <a:cs typeface="+mn-cs"/>
        </a:defRPr>
      </a:lvl1pPr>
      <a:lvl2pPr marL="648081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2268" kern="1200">
          <a:solidFill>
            <a:schemeClr val="tx1"/>
          </a:solidFill>
          <a:latin typeface="+mn-lt"/>
          <a:ea typeface="+mn-ea"/>
          <a:cs typeface="+mn-cs"/>
        </a:defRPr>
      </a:lvl2pPr>
      <a:lvl3pPr marL="1080135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512189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4pPr>
      <a:lvl5pPr marL="1944243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5pPr>
      <a:lvl6pPr marL="2376297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6pPr>
      <a:lvl7pPr marL="2808351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7pPr>
      <a:lvl8pPr marL="3240405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8pPr>
      <a:lvl9pPr marL="3672459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1pPr>
      <a:lvl2pPr marL="432054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2pPr>
      <a:lvl3pPr marL="864108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3pPr>
      <a:lvl4pPr marL="1296162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4pPr>
      <a:lvl5pPr marL="1728216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5pPr>
      <a:lvl6pPr marL="2160270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6pPr>
      <a:lvl7pPr marL="2592324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7pPr>
      <a:lvl8pPr marL="3024378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8pPr>
      <a:lvl9pPr marL="3456432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oup 18">
            <a:extLst>
              <a:ext uri="{FF2B5EF4-FFF2-40B4-BE49-F238E27FC236}">
                <a16:creationId xmlns:a16="http://schemas.microsoft.com/office/drawing/2014/main" id="{64B78489-0E5C-9ABA-0415-52EAAC79C5A5}"/>
              </a:ext>
            </a:extLst>
          </p:cNvPr>
          <p:cNvGrpSpPr/>
          <p:nvPr/>
        </p:nvGrpSpPr>
        <p:grpSpPr>
          <a:xfrm>
            <a:off x="-18193" y="53000"/>
            <a:ext cx="8775802" cy="6776473"/>
            <a:chOff x="-18193" y="53000"/>
            <a:chExt cx="8775802" cy="6776473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3DE86D50-D5A5-3B3D-FC1E-D850C8808BE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t="3251" r="4487" b="2686"/>
            <a:stretch/>
          </p:blipFill>
          <p:spPr>
            <a:xfrm>
              <a:off x="148975" y="209750"/>
              <a:ext cx="8482502" cy="6422828"/>
            </a:xfrm>
            <a:prstGeom prst="rect">
              <a:avLst/>
            </a:prstGeom>
          </p:spPr>
        </p:pic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69E96377-06E2-B53E-D836-FE6799F04139}"/>
                </a:ext>
              </a:extLst>
            </p:cNvPr>
            <p:cNvGrpSpPr/>
            <p:nvPr/>
          </p:nvGrpSpPr>
          <p:grpSpPr>
            <a:xfrm>
              <a:off x="226978" y="53000"/>
              <a:ext cx="7500163" cy="201691"/>
              <a:chOff x="5501634" y="135467"/>
              <a:chExt cx="3103674" cy="93098"/>
            </a:xfrm>
            <a:solidFill>
              <a:schemeClr val="bg1"/>
            </a:solidFill>
          </p:grpSpPr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B1DD2B7D-33F0-0306-E2CC-4D9C2F42C6CD}"/>
                  </a:ext>
                </a:extLst>
              </p:cNvPr>
              <p:cNvSpPr txBox="1"/>
              <p:nvPr/>
            </p:nvSpPr>
            <p:spPr>
              <a:xfrm>
                <a:off x="5501634" y="136222"/>
                <a:ext cx="242471" cy="92343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G1</a:t>
                </a:r>
                <a:endParaRPr lang="en-IN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8B659121-7416-3AA5-4D56-27289852B578}"/>
                  </a:ext>
                </a:extLst>
              </p:cNvPr>
              <p:cNvSpPr txBox="1"/>
              <p:nvPr/>
            </p:nvSpPr>
            <p:spPr>
              <a:xfrm>
                <a:off x="5861107" y="135467"/>
                <a:ext cx="230997" cy="92343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G2</a:t>
                </a:r>
                <a:endParaRPr lang="en-IN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CFDB8398-7C46-5CD3-1781-E2E49F2043CA}"/>
                  </a:ext>
                </a:extLst>
              </p:cNvPr>
              <p:cNvSpPr txBox="1"/>
              <p:nvPr/>
            </p:nvSpPr>
            <p:spPr>
              <a:xfrm>
                <a:off x="6383006" y="135467"/>
                <a:ext cx="294952" cy="92343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G3</a:t>
                </a:r>
                <a:endParaRPr lang="en-IN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44FF8E1B-4410-231D-3AA4-832DCE6D62C7}"/>
                  </a:ext>
                </a:extLst>
              </p:cNvPr>
              <p:cNvSpPr txBox="1"/>
              <p:nvPr/>
            </p:nvSpPr>
            <p:spPr>
              <a:xfrm>
                <a:off x="6958128" y="135467"/>
                <a:ext cx="294952" cy="92343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G4</a:t>
                </a:r>
                <a:endParaRPr lang="en-IN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1B4B7065-CD91-6B04-9980-D538FB47C4E1}"/>
                  </a:ext>
                </a:extLst>
              </p:cNvPr>
              <p:cNvSpPr txBox="1"/>
              <p:nvPr/>
            </p:nvSpPr>
            <p:spPr>
              <a:xfrm>
                <a:off x="7315554" y="135467"/>
                <a:ext cx="286078" cy="92343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G5</a:t>
                </a:r>
                <a:endParaRPr lang="en-IN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2F31A54C-4EFF-5233-E0A6-15F11B2D016E}"/>
                  </a:ext>
                </a:extLst>
              </p:cNvPr>
              <p:cNvSpPr txBox="1"/>
              <p:nvPr/>
            </p:nvSpPr>
            <p:spPr>
              <a:xfrm>
                <a:off x="7854975" y="135467"/>
                <a:ext cx="242471" cy="92343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G6</a:t>
                </a:r>
                <a:endParaRPr lang="en-IN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02868FA2-7C12-A0FF-3CBB-FA659CDD89B9}"/>
                  </a:ext>
                </a:extLst>
              </p:cNvPr>
              <p:cNvSpPr txBox="1"/>
              <p:nvPr/>
            </p:nvSpPr>
            <p:spPr>
              <a:xfrm>
                <a:off x="8362837" y="135467"/>
                <a:ext cx="242471" cy="92343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G7</a:t>
                </a:r>
                <a:endParaRPr lang="en-IN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6422973E-0CA3-B681-4790-52EC42C7DF31}"/>
                </a:ext>
              </a:extLst>
            </p:cNvPr>
            <p:cNvGrpSpPr/>
            <p:nvPr/>
          </p:nvGrpSpPr>
          <p:grpSpPr>
            <a:xfrm>
              <a:off x="5913929" y="6432883"/>
              <a:ext cx="2023249" cy="207190"/>
              <a:chOff x="198373" y="6638245"/>
              <a:chExt cx="2023249" cy="207190"/>
            </a:xfrm>
          </p:grpSpPr>
          <p:sp>
            <p:nvSpPr>
              <p:cNvPr id="14" name="Rectangle 13">
                <a:extLst>
                  <a:ext uri="{FF2B5EF4-FFF2-40B4-BE49-F238E27FC236}">
                    <a16:creationId xmlns:a16="http://schemas.microsoft.com/office/drawing/2014/main" id="{B0D99888-D8CB-ABE4-2F7E-108AE92A70EB}"/>
                  </a:ext>
                </a:extLst>
              </p:cNvPr>
              <p:cNvSpPr/>
              <p:nvPr/>
            </p:nvSpPr>
            <p:spPr>
              <a:xfrm>
                <a:off x="1711363" y="6717059"/>
                <a:ext cx="132054" cy="46691"/>
              </a:xfrm>
              <a:prstGeom prst="rect">
                <a:avLst/>
              </a:prstGeom>
              <a:solidFill>
                <a:srgbClr val="008000"/>
              </a:solidFill>
              <a:ln>
                <a:solidFill>
                  <a:srgbClr val="008000"/>
                </a:solidFill>
              </a:ln>
            </p:spPr>
            <p:style>
              <a:lnRef idx="2">
                <a:schemeClr val="accent6">
                  <a:shade val="15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 sz="1850"/>
              </a:p>
            </p:txBody>
          </p:sp>
          <p:sp>
            <p:nvSpPr>
              <p:cNvPr id="15" name="Rectangle 14">
                <a:extLst>
                  <a:ext uri="{FF2B5EF4-FFF2-40B4-BE49-F238E27FC236}">
                    <a16:creationId xmlns:a16="http://schemas.microsoft.com/office/drawing/2014/main" id="{0DC8972A-3EE5-06C2-31C4-97D39D0BDBF7}"/>
                  </a:ext>
                </a:extLst>
              </p:cNvPr>
              <p:cNvSpPr/>
              <p:nvPr/>
            </p:nvSpPr>
            <p:spPr>
              <a:xfrm>
                <a:off x="198373" y="6717057"/>
                <a:ext cx="132054" cy="46691"/>
              </a:xfrm>
              <a:prstGeom prst="rect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6">
                  <a:shade val="15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 sz="1850"/>
              </a:p>
            </p:txBody>
          </p:sp>
          <p:sp>
            <p:nvSpPr>
              <p:cNvPr id="16" name="Rectangle 15">
                <a:extLst>
                  <a:ext uri="{FF2B5EF4-FFF2-40B4-BE49-F238E27FC236}">
                    <a16:creationId xmlns:a16="http://schemas.microsoft.com/office/drawing/2014/main" id="{0B9C1CC9-178F-85BA-A9AF-1B7694A7AD3D}"/>
                  </a:ext>
                </a:extLst>
              </p:cNvPr>
              <p:cNvSpPr/>
              <p:nvPr/>
            </p:nvSpPr>
            <p:spPr>
              <a:xfrm>
                <a:off x="702479" y="6717059"/>
                <a:ext cx="132054" cy="46691"/>
              </a:xfrm>
              <a:prstGeom prst="rect">
                <a:avLst/>
              </a:prstGeom>
              <a:solidFill>
                <a:srgbClr val="800000"/>
              </a:solidFill>
              <a:ln>
                <a:solidFill>
                  <a:srgbClr val="800000"/>
                </a:solidFill>
              </a:ln>
            </p:spPr>
            <p:style>
              <a:lnRef idx="2">
                <a:schemeClr val="accent6">
                  <a:shade val="15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 sz="1850"/>
              </a:p>
            </p:txBody>
          </p:sp>
          <p:sp>
            <p:nvSpPr>
              <p:cNvPr id="17" name="Rectangle 16">
                <a:extLst>
                  <a:ext uri="{FF2B5EF4-FFF2-40B4-BE49-F238E27FC236}">
                    <a16:creationId xmlns:a16="http://schemas.microsoft.com/office/drawing/2014/main" id="{EF933098-2C36-782D-CB6E-512FE00E7E24}"/>
                  </a:ext>
                </a:extLst>
              </p:cNvPr>
              <p:cNvSpPr/>
              <p:nvPr/>
            </p:nvSpPr>
            <p:spPr>
              <a:xfrm>
                <a:off x="1207258" y="6717059"/>
                <a:ext cx="132054" cy="46691"/>
              </a:xfrm>
              <a:prstGeom prst="rect">
                <a:avLst/>
              </a:prstGeom>
              <a:solidFill>
                <a:srgbClr val="1B1B94"/>
              </a:solidFill>
              <a:ln>
                <a:solidFill>
                  <a:srgbClr val="1B1B94"/>
                </a:solidFill>
              </a:ln>
            </p:spPr>
            <p:style>
              <a:lnRef idx="2">
                <a:schemeClr val="accent6">
                  <a:shade val="15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 sz="1850"/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A8FE4FE2-4C4E-573D-86DA-F28E5B261091}"/>
                  </a:ext>
                </a:extLst>
              </p:cNvPr>
              <p:cNvSpPr txBox="1"/>
              <p:nvPr/>
            </p:nvSpPr>
            <p:spPr>
              <a:xfrm>
                <a:off x="311558" y="6638245"/>
                <a:ext cx="397753" cy="2071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18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006</a:t>
                </a:r>
                <a:endParaRPr lang="en-IN" sz="718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AFEC3616-D6CA-1FA4-40F0-6CD7EEECD644}"/>
                  </a:ext>
                </a:extLst>
              </p:cNvPr>
              <p:cNvSpPr txBox="1"/>
              <p:nvPr/>
            </p:nvSpPr>
            <p:spPr>
              <a:xfrm>
                <a:off x="815662" y="6638247"/>
                <a:ext cx="397753" cy="2071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18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007</a:t>
                </a:r>
                <a:endParaRPr lang="en-IN" sz="718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2E41ABFE-B191-3B8B-FC9E-A69885084CC9}"/>
                  </a:ext>
                </a:extLst>
              </p:cNvPr>
              <p:cNvSpPr txBox="1"/>
              <p:nvPr/>
            </p:nvSpPr>
            <p:spPr>
              <a:xfrm>
                <a:off x="1319766" y="6638247"/>
                <a:ext cx="397753" cy="2071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18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009</a:t>
                </a:r>
                <a:endParaRPr lang="en-IN" sz="718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11B9AFF1-4A43-B016-8A18-306E6616AF12}"/>
                  </a:ext>
                </a:extLst>
              </p:cNvPr>
              <p:cNvSpPr txBox="1"/>
              <p:nvPr/>
            </p:nvSpPr>
            <p:spPr>
              <a:xfrm>
                <a:off x="1823869" y="6638247"/>
                <a:ext cx="397753" cy="2071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18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01</a:t>
                </a:r>
                <a:r>
                  <a:rPr lang="en-IN" sz="718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lang="en-US" sz="718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FC2E985D-E2F8-7A3D-70A5-5757BAB040FA}"/>
                </a:ext>
              </a:extLst>
            </p:cNvPr>
            <p:cNvSpPr txBox="1"/>
            <p:nvPr/>
          </p:nvSpPr>
          <p:spPr>
            <a:xfrm rot="16200000">
              <a:off x="-326914" y="3312049"/>
              <a:ext cx="8174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Position (</a:t>
              </a:r>
              <a:r>
                <a:rPr lang="en-US" sz="7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M</a:t>
              </a:r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IN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D4346A8B-9D69-7D60-568C-5E17B2F2D8CA}"/>
                </a:ext>
              </a:extLst>
            </p:cNvPr>
            <p:cNvSpPr txBox="1"/>
            <p:nvPr/>
          </p:nvSpPr>
          <p:spPr>
            <a:xfrm>
              <a:off x="463179" y="6629418"/>
              <a:ext cx="829443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PH-Plant Height; </a:t>
              </a:r>
              <a:r>
                <a:rPr lang="en-US" sz="7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tD</a:t>
              </a:r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Stem Diameter; </a:t>
              </a:r>
              <a:r>
                <a:rPr lang="en-US" sz="7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nD</a:t>
              </a:r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Panicle Diameter; </a:t>
              </a:r>
              <a:r>
                <a:rPr lang="en-US" sz="7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nL</a:t>
              </a:r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Panicle Length; GY-Grain Yield; TSW-1000 Seed Weight; PLSD-</a:t>
              </a:r>
              <a:r>
                <a:rPr lang="en-US" sz="7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yricularia</a:t>
              </a:r>
              <a:r>
                <a:rPr lang="en-US" sz="7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Leaf Spot Disease; EM-</a:t>
              </a:r>
              <a:r>
                <a:rPr lang="en-US" sz="7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Eggmass</a:t>
              </a:r>
              <a:endParaRPr 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5472907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2</TotalTime>
  <Words>42</Words>
  <Application>Microsoft Office PowerPoint</Application>
  <PresentationFormat>Custom</PresentationFormat>
  <Paragraphs>1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airam Vutla</dc:creator>
  <cp:lastModifiedBy>Sairam Vutla</cp:lastModifiedBy>
  <cp:revision>1</cp:revision>
  <dcterms:created xsi:type="dcterms:W3CDTF">2025-03-04T01:24:24Z</dcterms:created>
  <dcterms:modified xsi:type="dcterms:W3CDTF">2025-03-05T03:40:18Z</dcterms:modified>
</cp:coreProperties>
</file>